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9" r:id="rId3"/>
    <p:sldId id="262" r:id="rId4"/>
    <p:sldId id="257" r:id="rId5"/>
    <p:sldId id="258" r:id="rId6"/>
    <p:sldId id="260" r:id="rId7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>
      <p:cViewPr>
        <p:scale>
          <a:sx n="70" d="100"/>
          <a:sy n="70" d="100"/>
        </p:scale>
        <p:origin x="-1084" y="-8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F709D2-9A5B-4B8C-87E2-4C568B36A236}" type="datetimeFigureOut">
              <a:rPr lang="en-US" smtClean="0"/>
              <a:t>2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B634DB-8063-422C-9F9C-5BD28A3A79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62360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F709D2-9A5B-4B8C-87E2-4C568B36A236}" type="datetimeFigureOut">
              <a:rPr lang="en-US" smtClean="0"/>
              <a:t>2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B634DB-8063-422C-9F9C-5BD28A3A79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80320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F709D2-9A5B-4B8C-87E2-4C568B36A236}" type="datetimeFigureOut">
              <a:rPr lang="en-US" smtClean="0"/>
              <a:t>2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B634DB-8063-422C-9F9C-5BD28A3A79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80140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F709D2-9A5B-4B8C-87E2-4C568B36A236}" type="datetimeFigureOut">
              <a:rPr lang="en-US" smtClean="0"/>
              <a:t>2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B634DB-8063-422C-9F9C-5BD28A3A79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89635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F709D2-9A5B-4B8C-87E2-4C568B36A236}" type="datetimeFigureOut">
              <a:rPr lang="en-US" smtClean="0"/>
              <a:t>2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B634DB-8063-422C-9F9C-5BD28A3A79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40880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F709D2-9A5B-4B8C-87E2-4C568B36A236}" type="datetimeFigureOut">
              <a:rPr lang="en-US" smtClean="0"/>
              <a:t>2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B634DB-8063-422C-9F9C-5BD28A3A79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34980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F709D2-9A5B-4B8C-87E2-4C568B36A236}" type="datetimeFigureOut">
              <a:rPr lang="en-US" smtClean="0"/>
              <a:t>2/19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B634DB-8063-422C-9F9C-5BD28A3A79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8335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F709D2-9A5B-4B8C-87E2-4C568B36A236}" type="datetimeFigureOut">
              <a:rPr lang="en-US" smtClean="0"/>
              <a:t>2/19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B634DB-8063-422C-9F9C-5BD28A3A79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9961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F709D2-9A5B-4B8C-87E2-4C568B36A236}" type="datetimeFigureOut">
              <a:rPr lang="en-US" smtClean="0"/>
              <a:t>2/19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B634DB-8063-422C-9F9C-5BD28A3A79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31846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F709D2-9A5B-4B8C-87E2-4C568B36A236}" type="datetimeFigureOut">
              <a:rPr lang="en-US" smtClean="0"/>
              <a:t>2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B634DB-8063-422C-9F9C-5BD28A3A79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03309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F709D2-9A5B-4B8C-87E2-4C568B36A236}" type="datetimeFigureOut">
              <a:rPr lang="en-US" smtClean="0"/>
              <a:t>2/19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B634DB-8063-422C-9F9C-5BD28A3A79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07022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F709D2-9A5B-4B8C-87E2-4C568B36A236}" type="datetimeFigureOut">
              <a:rPr lang="en-US" smtClean="0"/>
              <a:t>2/19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B634DB-8063-422C-9F9C-5BD28A3A79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1565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5536" y="44624"/>
            <a:ext cx="8306312" cy="6243532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2339752" y="1340768"/>
            <a:ext cx="2208940" cy="1728192"/>
          </a:xfrm>
          <a:prstGeom prst="rect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Rectangle 3"/>
          <p:cNvSpPr/>
          <p:nvPr/>
        </p:nvSpPr>
        <p:spPr>
          <a:xfrm>
            <a:off x="2339752" y="1340768"/>
            <a:ext cx="4104456" cy="3240360"/>
          </a:xfrm>
          <a:prstGeom prst="rect">
            <a:avLst/>
          </a:prstGeom>
          <a:noFill/>
          <a:ln w="38100">
            <a:solidFill>
              <a:srgbClr val="FFFF00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/>
          <p:cNvSpPr txBox="1"/>
          <p:nvPr/>
        </p:nvSpPr>
        <p:spPr>
          <a:xfrm>
            <a:off x="152231" y="6187112"/>
            <a:ext cx="8812257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Suppl. Fig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S5a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: LD map for the TRJ subpopulation on chromosome 1 (7.1 – 7.5 Mb). The yellow box frames a linkage block between 7.22 – 7.31 Mb that contains the peak for PUE (1.4E-04 at 7.30 Mb) detected in </a:t>
            </a:r>
            <a:r>
              <a:rPr lang="en-US" sz="1400" dirty="0" err="1" smtClean="0">
                <a:latin typeface="Times New Roman" pitchFamily="18" charset="0"/>
                <a:cs typeface="Times New Roman" pitchFamily="18" charset="0"/>
              </a:rPr>
              <a:t>Exp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1. The dashed yellow box extends the linkage block to 7.365 Mb at less tight linkage.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233682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2790" y="9526"/>
            <a:ext cx="7645634" cy="6381328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2499008" y="1302668"/>
            <a:ext cx="2066599" cy="1838300"/>
          </a:xfrm>
          <a:prstGeom prst="rect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Rectangle 3"/>
          <p:cNvSpPr/>
          <p:nvPr/>
        </p:nvSpPr>
        <p:spPr>
          <a:xfrm>
            <a:off x="4563153" y="3087628"/>
            <a:ext cx="2297863" cy="2133952"/>
          </a:xfrm>
          <a:prstGeom prst="rect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" name="TextBox 4"/>
          <p:cNvSpPr txBox="1"/>
          <p:nvPr/>
        </p:nvSpPr>
        <p:spPr>
          <a:xfrm>
            <a:off x="1" y="6274200"/>
            <a:ext cx="914400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Suppl. Fig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S5b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: 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LD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map for the indica subpopulation on chromosome 1 (7.1 – 7.5 Mb). Two yellow boxes frame linkage blocks between 7.13 – 7.27 Mb and 7.286 – 7.365 Mb containing the peak for PUE (1.9E-03 at 7.275 Mb) detected in </a:t>
            </a:r>
            <a:r>
              <a:rPr lang="en-US" sz="1400" dirty="0" err="1" smtClean="0">
                <a:latin typeface="Times New Roman" pitchFamily="18" charset="0"/>
                <a:cs typeface="Times New Roman" pitchFamily="18" charset="0"/>
              </a:rPr>
              <a:t>Exp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2. 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576103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52231" y="6187112"/>
            <a:ext cx="881225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Suppl. Fig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S5c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: 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LD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map for the indica subpopulation on chromosome 1 (41.30 – 42.06 Mb). The yellow circle indicates the position of the peak for PUE (1.9E-03 at 41.779 Mb) detected in </a:t>
            </a:r>
            <a:r>
              <a:rPr lang="en-US" sz="1400" dirty="0" err="1" smtClean="0">
                <a:latin typeface="Times New Roman" pitchFamily="18" charset="0"/>
                <a:cs typeface="Times New Roman" pitchFamily="18" charset="0"/>
              </a:rPr>
              <a:t>Exp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1 and 2, which is outside any linkage block. 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03648" y="3810"/>
            <a:ext cx="6397714" cy="5984958"/>
          </a:xfrm>
          <a:prstGeom prst="rect">
            <a:avLst/>
          </a:prstGeom>
        </p:spPr>
      </p:pic>
      <p:sp>
        <p:nvSpPr>
          <p:cNvPr id="7" name="Oval 6"/>
          <p:cNvSpPr/>
          <p:nvPr/>
        </p:nvSpPr>
        <p:spPr>
          <a:xfrm>
            <a:off x="4173860" y="2572524"/>
            <a:ext cx="457200" cy="313184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154834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3004" y="333296"/>
            <a:ext cx="5938148" cy="5760000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2692466" y="1753766"/>
            <a:ext cx="1807526" cy="1910308"/>
          </a:xfrm>
          <a:prstGeom prst="rect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/>
          <p:cNvSpPr txBox="1"/>
          <p:nvPr/>
        </p:nvSpPr>
        <p:spPr>
          <a:xfrm>
            <a:off x="152231" y="6187112"/>
            <a:ext cx="847317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Suppl. Fig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S5d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: 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LD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map for the indica subpopulation on chromosome 4 (17.4 – 18.0 Mb). The yellow box frames a linkage block between 17.70 – 17.85 Mb that contains the peak for PUE (2.0E-06 at 17.85 Mb) detected in </a:t>
            </a:r>
            <a:r>
              <a:rPr lang="en-US" sz="1400" dirty="0" err="1" smtClean="0">
                <a:latin typeface="Times New Roman" pitchFamily="18" charset="0"/>
                <a:cs typeface="Times New Roman" pitchFamily="18" charset="0"/>
              </a:rPr>
              <a:t>Exp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2.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5918528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03648" y="44624"/>
            <a:ext cx="6603626" cy="5966261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3882401" y="2269252"/>
            <a:ext cx="1337672" cy="1303764"/>
          </a:xfrm>
          <a:prstGeom prst="rect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" name="TextBox 3"/>
          <p:cNvSpPr txBox="1"/>
          <p:nvPr/>
        </p:nvSpPr>
        <p:spPr>
          <a:xfrm>
            <a:off x="152231" y="6187112"/>
            <a:ext cx="847317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Suppl. Fig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S5e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: 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LD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map for the aus subpopulation on chromosome 11 (16.2 – 17.2 Mb). The yellow box frames a linkage block between 16.63 – 16.75 Mb that contains the peak for PUE at 16.74 Mb detected in </a:t>
            </a:r>
            <a:r>
              <a:rPr lang="en-US" sz="1400" dirty="0" err="1" smtClean="0">
                <a:latin typeface="Times New Roman" pitchFamily="18" charset="0"/>
                <a:cs typeface="Times New Roman" pitchFamily="18" charset="0"/>
              </a:rPr>
              <a:t>Exp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1 and 2.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5918528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37330" y="3810"/>
            <a:ext cx="6059006" cy="6059006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52231" y="6110874"/>
            <a:ext cx="8473177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Suppl. Fig. S5f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: </a:t>
            </a:r>
            <a:r>
              <a:rPr lang="en-US" sz="1400" dirty="0">
                <a:latin typeface="Times New Roman" pitchFamily="18" charset="0"/>
                <a:cs typeface="Times New Roman" pitchFamily="18" charset="0"/>
              </a:rPr>
              <a:t>LD 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map for the indica subpopulation on chromosome 12 (26.1 – 27.2 Mb). The yellow circle indicates the peak for PUE at 26.656 Mb detected in </a:t>
            </a:r>
            <a:r>
              <a:rPr lang="en-US" sz="1400" dirty="0" err="1" smtClean="0">
                <a:latin typeface="Times New Roman" pitchFamily="18" charset="0"/>
                <a:cs typeface="Times New Roman" pitchFamily="18" charset="0"/>
              </a:rPr>
              <a:t>Exp</a:t>
            </a:r>
            <a:r>
              <a:rPr lang="en-US" sz="1400" dirty="0" smtClean="0">
                <a:latin typeface="Times New Roman" pitchFamily="18" charset="0"/>
                <a:cs typeface="Times New Roman" pitchFamily="18" charset="0"/>
              </a:rPr>
              <a:t> 2. This peak is not associated with any linkage block but bordered by blocks between 26.42-26.63 Mb and 26.73-26.93 Mb..</a:t>
            </a:r>
            <a:endParaRPr 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Oval 3"/>
          <p:cNvSpPr/>
          <p:nvPr/>
        </p:nvSpPr>
        <p:spPr>
          <a:xfrm>
            <a:off x="4292724" y="2678440"/>
            <a:ext cx="457200" cy="313184"/>
          </a:xfrm>
          <a:prstGeom prst="ellipse">
            <a:avLst/>
          </a:prstGeom>
          <a:noFill/>
          <a:ln w="38100">
            <a:solidFill>
              <a:srgbClr val="FFFF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7610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77</TotalTime>
  <Words>327</Words>
  <Application>Microsoft Office PowerPoint</Application>
  <PresentationFormat>On-screen Show (4:3)</PresentationFormat>
  <Paragraphs>6</Paragraphs>
  <Slides>6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Toshib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tthias</dc:creator>
  <cp:lastModifiedBy>Matthias</cp:lastModifiedBy>
  <cp:revision>31</cp:revision>
  <cp:lastPrinted>2013-07-17T07:54:00Z</cp:lastPrinted>
  <dcterms:created xsi:type="dcterms:W3CDTF">2013-07-17T07:35:33Z</dcterms:created>
  <dcterms:modified xsi:type="dcterms:W3CDTF">2015-02-19T02:25:31Z</dcterms:modified>
</cp:coreProperties>
</file>